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37" d="100"/>
          <a:sy n="137" d="100"/>
        </p:scale>
        <p:origin x="-360" y="-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145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654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149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793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880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162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748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211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789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803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137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04F5D1-9613-9047-8F93-D91B746BFC12}" type="datetimeFigureOut">
              <a:rPr lang="en-US" smtClean="0"/>
              <a:t>20/10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F76453-BC6B-CB43-A851-CBBDE8F887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630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0" Type="http://schemas.openxmlformats.org/officeDocument/2006/relationships/image" Target="../media/image9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9.emf"/><Relationship Id="rId12" Type="http://schemas.openxmlformats.org/officeDocument/2006/relationships/image" Target="../media/image20.emf"/><Relationship Id="rId13" Type="http://schemas.openxmlformats.org/officeDocument/2006/relationships/image" Target="../media/image21.emf"/><Relationship Id="rId14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emf"/><Relationship Id="rId3" Type="http://schemas.openxmlformats.org/officeDocument/2006/relationships/image" Target="../media/image11.emf"/><Relationship Id="rId4" Type="http://schemas.openxmlformats.org/officeDocument/2006/relationships/image" Target="../media/image12.emf"/><Relationship Id="rId5" Type="http://schemas.openxmlformats.org/officeDocument/2006/relationships/image" Target="../media/image13.emf"/><Relationship Id="rId6" Type="http://schemas.openxmlformats.org/officeDocument/2006/relationships/image" Target="../media/image14.emf"/><Relationship Id="rId7" Type="http://schemas.openxmlformats.org/officeDocument/2006/relationships/image" Target="../media/image15.emf"/><Relationship Id="rId8" Type="http://schemas.openxmlformats.org/officeDocument/2006/relationships/image" Target="../media/image16.emf"/><Relationship Id="rId9" Type="http://schemas.openxmlformats.org/officeDocument/2006/relationships/image" Target="../media/image17.emf"/><Relationship Id="rId10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24537" y="139002"/>
            <a:ext cx="1344148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LP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047947" y="139002"/>
            <a:ext cx="1440291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FSL-1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19521" y="131408"/>
            <a:ext cx="289003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824537" y="2281175"/>
            <a:ext cx="1485094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annexin-1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LP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11119" y="2281175"/>
            <a:ext cx="275459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849623" y="2281175"/>
            <a:ext cx="1840710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annexin-1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Pam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SK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849623" y="139002"/>
            <a:ext cx="1699646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Pam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SK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047947" y="2281175"/>
            <a:ext cx="1581236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annexin-1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FSL-1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824537" y="4527566"/>
            <a:ext cx="1151694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2X7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LP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211118" y="4527566"/>
            <a:ext cx="275459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2849622" y="4527566"/>
            <a:ext cx="1507285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2X7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Pam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SK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047947" y="4527566"/>
            <a:ext cx="1247837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2X7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FSL-1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953564" y="9561876"/>
            <a:ext cx="1780535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8771" y="166017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58" y="166017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0277" y="166017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57" y="2325164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8770" y="2325164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8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0212" y="2325164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1742" y="4601108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0212" y="4601108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1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95" y="4601108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362150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4176" y="2101235"/>
            <a:ext cx="2087676" cy="200089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825" y="2082287"/>
            <a:ext cx="2032752" cy="200089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953564" y="9561876"/>
            <a:ext cx="1780535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741" y="7931043"/>
            <a:ext cx="1994836" cy="18563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848277" y="-18208"/>
            <a:ext cx="1344148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LP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47947" y="-18208"/>
            <a:ext cx="1440291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FSL-1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9521" y="-25802"/>
            <a:ext cx="289003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4478" y="-57408"/>
            <a:ext cx="2317744" cy="21587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713" y="3960319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521" y="-18209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2" name="Picture 10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17" y="-18209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5" name="Picture 1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17" y="3960319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6" name="Picture 14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4477" y="3965010"/>
            <a:ext cx="2317744" cy="21587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7" name="Picture 15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4478" y="1983770"/>
            <a:ext cx="2317744" cy="21587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89" name="Picture 17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808" y="5957766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90" name="Picture 18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5417" y="5957766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91" name="Picture 19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4477" y="5957766"/>
            <a:ext cx="2321945" cy="21634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848277" y="2073894"/>
            <a:ext cx="1485094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annexin-1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LP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11119" y="2073894"/>
            <a:ext cx="275459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047947" y="2073894"/>
            <a:ext cx="1581236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annexin-1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FSL-1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48277" y="4043750"/>
            <a:ext cx="1151694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2X7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LP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11118" y="4043750"/>
            <a:ext cx="275459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5047947" y="4043750"/>
            <a:ext cx="1247837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2X7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FSL-1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848277" y="6053748"/>
            <a:ext cx="1209290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MaxiK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LP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047947" y="6046278"/>
            <a:ext cx="1305432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MaxiK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FSL-1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11118" y="6051890"/>
            <a:ext cx="275459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52825" y="7969937"/>
            <a:ext cx="267676" cy="256071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24015" y="-18208"/>
            <a:ext cx="1714142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Caspase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Pam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SK4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824015" y="2073894"/>
            <a:ext cx="1855087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annexin-1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Pam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SK4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824015" y="4043750"/>
            <a:ext cx="1521687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P2X7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Pam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SK4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824015" y="6046278"/>
            <a:ext cx="1584229" cy="225293"/>
          </a:xfrm>
          <a:prstGeom prst="rect">
            <a:avLst/>
          </a:prstGeom>
          <a:noFill/>
        </p:spPr>
        <p:txBody>
          <a:bodyPr wrap="none" lIns="85954" tIns="42977" rIns="85954" bIns="42977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MaxiK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inhib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+ Pam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SK4</a:t>
            </a:r>
            <a:endParaRPr lang="en-GB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75039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5</Words>
  <Application>Microsoft Macintosh PowerPoint</Application>
  <PresentationFormat>A4 Paper (210x297 mm)</PresentationFormat>
  <Paragraphs>3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ark Paul-Clark</dc:creator>
  <cp:keywords/>
  <dc:description/>
  <cp:lastModifiedBy>Mark Paul-Clark</cp:lastModifiedBy>
  <cp:revision>2</cp:revision>
  <dcterms:created xsi:type="dcterms:W3CDTF">2016-10-20T13:56:48Z</dcterms:created>
  <dcterms:modified xsi:type="dcterms:W3CDTF">2016-10-20T13:58:31Z</dcterms:modified>
  <cp:category/>
</cp:coreProperties>
</file>